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4660"/>
  </p:normalViewPr>
  <p:slideViewPr>
    <p:cSldViewPr snapToGrid="0">
      <p:cViewPr varScale="1">
        <p:scale>
          <a:sx n="53" d="100"/>
          <a:sy n="53" d="100"/>
        </p:scale>
        <p:origin x="16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2A795-86F2-7AB8-CEF6-38137245BD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841DC8-43F4-367A-5522-34F85BF9BB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889E47-F97C-C361-44A6-77D3257DF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5CD2ED-9049-94CF-4BA8-91CF7C2C7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0A7BA5-2468-7548-0CF2-6154628C8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529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7CA634-31AB-FE9C-0D99-BD019A640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2ED0E1-CD18-8AD1-0C0C-41DA633D55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1E9F78-EA30-126B-C207-15A4A383C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FAAA44-6973-29FD-5CF4-F9AE79242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347324-3214-347D-AF84-F8261DCEB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2088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6C49CA7-414C-1732-1008-61673BEFD8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2308C0-6D73-F0CB-2B18-B366F266B0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86604-138D-223D-265A-C068FA07EF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7CAE0C-8AF6-4F93-2C78-ED0FB8AE8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63BAD-04BA-7826-7C21-496BC73DE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040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E6834C-04C8-9426-AA4A-37776AC75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ED80A5-408A-4838-C87B-1E1378FDD2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576CF3-A191-9791-BC0B-84C89AE2B3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60346-592A-D05C-8A28-EC6C45644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0CC703-016C-9E39-25E2-315928D36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5781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E7C0FA-D6BA-4F84-8543-9B1CAE5AB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5EA7A2-091F-E0CC-BFA4-6AA4F629B8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04614C-6A1D-165B-E38B-54E344A6A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9D0A33-C48F-3F1A-9A6A-0D932EBFB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BA993-C180-CB3E-F626-3EB75983D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228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4B227-7518-868E-E3F9-F2C8A4AC52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F363BF-9098-BAED-6A38-A27BAE7E9C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BEFB2B-7475-8D98-2F36-31D5F727DF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B87983-0295-C146-3289-76ADE7954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9F07AC-B8E8-A701-F97E-BC165C5275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D5AA39-EA07-71F6-A087-D9EBBF885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10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B628A-6AE7-3E7F-C6CA-CC7771854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B4803B-FC98-3432-19BC-BA79DB5F55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EAA3DE-A902-6408-FE63-1BA47A76D2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0D4C68-E4E9-003F-34F3-CC16E3B05C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24768B-0ADF-1452-5600-C1E1928724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B6CF31-5CAA-9034-AF29-0B1871E5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9051528-4704-AF8B-6B88-DA0C0D47F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320206-D694-F8F4-9AE7-98C618FBA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344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7B6F3-FF78-8D03-38BC-A7E3D682AD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C7D41C-D109-4C96-C899-D4AA26285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37D526-D794-D433-850B-97AD19F348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8F745A-17E8-8DAA-AE59-57D2160FD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809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E06DBFC-5668-D264-21E4-120E95E8D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F89915-8A4E-9752-6638-CAAA600F5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66EA9D9-D27C-A360-43D4-F0D46045F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509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B35D8-A8B0-5BC0-034B-6B1FB6B0A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A61C43-1261-C60D-08E9-A2B7724A1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40BBA0-56D6-13BC-2F0A-1F836977C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1D61AE-1483-B9B1-0206-B08E76AD9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AD4AFC-981F-EA72-AEA7-83C21BE9D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16D3C-F19D-E9C8-3131-FF1029E1B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403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8ED52D-6388-A152-995F-24FA4AB20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45A558-3082-30CA-EF85-176000D27D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52E186-0D81-9937-237D-7B3F17D86A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C6F676-D512-F3FD-3298-8F37ED56F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A1BB0A-B1E4-E9F2-24F4-73CEE253D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289824-55C9-8E7E-31FA-40791E025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32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C11068-3436-9EF4-CD80-AAE60AB704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00708F-2318-FE40-E858-C216AFBBE5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EC415-C6D7-539F-EE99-D9ABF71D65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F3485A-7F55-41D9-9230-FF6C872D6486}" type="datetimeFigureOut">
              <a:rPr lang="en-US" smtClean="0"/>
              <a:t>7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6C1FD-0869-A636-D8DF-68A21E40DE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602574-656B-FCF3-5FB9-5EA713C1E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52E6BA-808A-40A5-9127-3CA1FD3BB9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06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graph of different lines&#10;&#10;AI-generated content may be incorrect.">
            <a:extLst>
              <a:ext uri="{FF2B5EF4-FFF2-40B4-BE49-F238E27FC236}">
                <a16:creationId xmlns:a16="http://schemas.microsoft.com/office/drawing/2014/main" id="{CE805E53-8297-25E2-4486-B98B913CB0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47369" y="0"/>
            <a:ext cx="7366098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BD83875-D26C-B76F-B6CE-14E4608C38CA}"/>
              </a:ext>
            </a:extLst>
          </p:cNvPr>
          <p:cNvSpPr txBox="1"/>
          <p:nvPr/>
        </p:nvSpPr>
        <p:spPr>
          <a:xfrm>
            <a:off x="6803136" y="530352"/>
            <a:ext cx="538886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2. Changes in liver function markers (TBIL, ALB) at different time points during HBV-TCR-T cell treatment. TBIL: Total bilirubin. ALB: Albumin. The shaded square area in the graph represents the normal range for each </a:t>
            </a:r>
            <a:r>
              <a:rPr lang="en-US" dirty="0" err="1"/>
              <a:t>marker.The</a:t>
            </a:r>
            <a:r>
              <a:rPr lang="en-US" dirty="0"/>
              <a:t> black dashed line indicates the time points of mRNA-HBV-TCR-T cell infusion, and the red dashed line indicates the time points of </a:t>
            </a:r>
            <a:r>
              <a:rPr lang="en-US" dirty="0" err="1"/>
              <a:t>lenti</a:t>
            </a:r>
            <a:r>
              <a:rPr lang="en-US" dirty="0"/>
              <a:t>-HBV-TCR-T cell infusion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7111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egmann, Bill</dc:creator>
  <cp:lastModifiedBy>Siegmann, Bill</cp:lastModifiedBy>
  <cp:revision>1</cp:revision>
  <dcterms:created xsi:type="dcterms:W3CDTF">2025-07-21T15:57:13Z</dcterms:created>
  <dcterms:modified xsi:type="dcterms:W3CDTF">2025-07-21T15:58:17Z</dcterms:modified>
</cp:coreProperties>
</file>